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62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40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589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148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758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982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463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01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2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32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28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765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D6E18-3FE0-AC41-8C77-DE2BA46B6ADA}" type="datetimeFigureOut">
              <a:rPr lang="en-US" smtClean="0"/>
              <a:t>28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F1EEE-D664-564E-B885-9B3A1E104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020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0870906"/>
              </p:ext>
            </p:extLst>
          </p:nvPr>
        </p:nvGraphicFramePr>
        <p:xfrm>
          <a:off x="787085" y="1992397"/>
          <a:ext cx="7441369" cy="2741808"/>
        </p:xfrm>
        <a:graphic>
          <a:graphicData uri="http://schemas.openxmlformats.org/drawingml/2006/table">
            <a:tbl>
              <a:tblPr/>
              <a:tblGrid>
                <a:gridCol w="3075155"/>
                <a:gridCol w="2158161"/>
                <a:gridCol w="2208053"/>
              </a:tblGrid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Annotation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Forward Primer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Reverse Primer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NAC domain-containing protein 72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GCAAGCTGAGCTGGGAAAG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TACAGCGGCGATTTTCGTA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Protein HVA22-like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ATACAAGAAAGCTGCCCCTT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TGGTACGATGTGAAGTTGGTGT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Aquaporin PIP1;2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AGCACAAAGGTGCCCACA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TGCCGCAGGATACAGCA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Heat shock factor 4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GTGGACCCACAGTTGATTCCT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TCACCTTCCTGACCAAGTACATG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BL-interacting protein kinase 08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CCACGAAGCCTCCT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GGCAGAGCGTGGCGATA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NAC family transcription factor 5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ACACCCTAATCCGATGCTAATCTT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CCGGATCTATCGCTAAA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Dessication responsive protein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GCCGAAGCGTATTTCAAAGTG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GACTCATCTCCAGCTTCTGGTAC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Mitogen-activated protein kinase kinase kinase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GAGGCCGAGTACCCTT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AGTGGGCGTTGTGTTGC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Uncharacterized protein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GACGACGACGAGTGGT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GCTCGATCATCAAGAAGAG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Heat shock protein 90-2 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CGTTTTGAGAGTTTGACTGAC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GGCACAATGTGAATGAAG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Elongattion Factor 1alph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CGGCATCACCATTCTTCA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</a:rPr>
                        <a:t>CGACCGTAGGTCTGGAAAGG</a:t>
                      </a:r>
                    </a:p>
                  </a:txBody>
                  <a:tcPr marL="11927" marR="11927" marT="119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162420" y="1573606"/>
            <a:ext cx="43866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900" dirty="0" smtClean="0">
                <a:latin typeface="Verdana"/>
                <a:cs typeface="Verdana"/>
              </a:rPr>
              <a:t>Supporting Table </a:t>
            </a:r>
            <a:r>
              <a:rPr lang="en-US" sz="900" dirty="0" smtClean="0">
                <a:latin typeface="Verdana"/>
                <a:cs typeface="Verdana"/>
              </a:rPr>
              <a:t>2. </a:t>
            </a:r>
            <a:r>
              <a:rPr lang="en-US" sz="900" dirty="0" smtClean="0">
                <a:latin typeface="Verdana"/>
                <a:cs typeface="Verdana"/>
              </a:rPr>
              <a:t>List of primers used for Quantitative Real Time PCR.</a:t>
            </a:r>
            <a:endParaRPr lang="en-US" sz="900" dirty="0">
              <a:latin typeface="Verdana"/>
              <a:cs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3506252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9</Words>
  <Application>Microsoft Macintosh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hra</dc:creator>
  <cp:lastModifiedBy>Bushra</cp:lastModifiedBy>
  <cp:revision>4</cp:revision>
  <dcterms:created xsi:type="dcterms:W3CDTF">2015-10-27T16:02:44Z</dcterms:created>
  <dcterms:modified xsi:type="dcterms:W3CDTF">2015-10-28T07:20:44Z</dcterms:modified>
</cp:coreProperties>
</file>